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4EFCE1-9F55-4334-9FAB-872ED94D5772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4A88C8-1A0A-4ED1-A77B-D178B8690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28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822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66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42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084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690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69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89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82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0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763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36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32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40479" y="1272257"/>
            <a:ext cx="1303279" cy="173736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62738" y="1272019"/>
            <a:ext cx="1412932" cy="173736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1617" y="1275285"/>
            <a:ext cx="1303279" cy="17373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91980" y="3519960"/>
            <a:ext cx="1324174" cy="17373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23019" y="3519960"/>
            <a:ext cx="1324174" cy="173736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90852" y="3512383"/>
            <a:ext cx="1326833" cy="1737360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 rot="16200000">
            <a:off x="4785925" y="4354703"/>
            <a:ext cx="1326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292628" y="5126682"/>
            <a:ext cx="416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571268" y="5126682"/>
            <a:ext cx="627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095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4402754" y="5384889"/>
            <a:ext cx="679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4356211" y="5384889"/>
            <a:ext cx="7742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946534" y="5126682"/>
            <a:ext cx="3892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6598314" y="4292337"/>
            <a:ext cx="11753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0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3180168" y="4288199"/>
            <a:ext cx="11047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4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992573" y="5126682"/>
            <a:ext cx="416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271213" y="5126682"/>
            <a:ext cx="627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095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6102699" y="5384889"/>
            <a:ext cx="679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6056156" y="5384889"/>
            <a:ext cx="7742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5646479" y="5126682"/>
            <a:ext cx="3892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607157" y="5126682"/>
            <a:ext cx="416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885797" y="5126682"/>
            <a:ext cx="627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095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7717283" y="5384889"/>
            <a:ext cx="679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7670740" y="5384889"/>
            <a:ext cx="7742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7261063" y="5126682"/>
            <a:ext cx="3892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0"/>
          <p:cNvSpPr txBox="1"/>
          <p:nvPr/>
        </p:nvSpPr>
        <p:spPr>
          <a:xfrm>
            <a:off x="4694141" y="3796557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</a:t>
            </a:r>
            <a:r>
              <a:rPr lang="en-US" sz="1200" dirty="0">
                <a:latin typeface="+mj-lt"/>
                <a:cs typeface="Arial" panose="020B0604020202020204" pitchFamily="34" charset="0"/>
              </a:rPr>
              <a:t>#</a:t>
            </a:r>
          </a:p>
          <a:p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4" name="TextBox 20"/>
          <p:cNvSpPr txBox="1"/>
          <p:nvPr/>
        </p:nvSpPr>
        <p:spPr>
          <a:xfrm>
            <a:off x="5982567" y="3729334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5" name="TextBox 20"/>
          <p:cNvSpPr txBox="1"/>
          <p:nvPr/>
        </p:nvSpPr>
        <p:spPr>
          <a:xfrm>
            <a:off x="6406339" y="4057793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</a:t>
            </a:r>
            <a:r>
              <a:rPr lang="en-US" sz="1200" dirty="0">
                <a:latin typeface="+mj-lt"/>
                <a:cs typeface="Arial" panose="020B0604020202020204" pitchFamily="34" charset="0"/>
              </a:rPr>
              <a:t>#</a:t>
            </a:r>
          </a:p>
          <a:p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3199215" y="2097813"/>
            <a:ext cx="11047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4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6431948" y="2085915"/>
            <a:ext cx="11753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0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4739300" y="2078629"/>
            <a:ext cx="1326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321203" y="2898196"/>
            <a:ext cx="416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599843" y="2898196"/>
            <a:ext cx="627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095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4431329" y="3156403"/>
            <a:ext cx="679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4384786" y="3156403"/>
            <a:ext cx="7742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3975109" y="2898196"/>
            <a:ext cx="3892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685550" y="2897495"/>
            <a:ext cx="416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7964190" y="2897495"/>
            <a:ext cx="627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095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7795676" y="3155702"/>
            <a:ext cx="679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7749133" y="3155702"/>
            <a:ext cx="7742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7339456" y="2897495"/>
            <a:ext cx="3892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965629" y="2890209"/>
            <a:ext cx="416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244269" y="2890209"/>
            <a:ext cx="627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095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6075755" y="3148416"/>
            <a:ext cx="679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/>
          </a:p>
        </p:txBody>
      </p:sp>
      <p:cxnSp>
        <p:nvCxnSpPr>
          <p:cNvPr id="45" name="Straight Connector 44"/>
          <p:cNvCxnSpPr/>
          <p:nvPr/>
        </p:nvCxnSpPr>
        <p:spPr>
          <a:xfrm>
            <a:off x="6029212" y="3148416"/>
            <a:ext cx="7742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5619535" y="2890209"/>
            <a:ext cx="3892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508666" y="111994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114776" y="111994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718058" y="111994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508666" y="346450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114776" y="346450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758132" y="3460618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18717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4</TotalTime>
  <Words>61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사용자</dc:creator>
  <cp:lastModifiedBy>Windows 사용자</cp:lastModifiedBy>
  <cp:revision>85</cp:revision>
  <dcterms:created xsi:type="dcterms:W3CDTF">2019-06-25T05:43:47Z</dcterms:created>
  <dcterms:modified xsi:type="dcterms:W3CDTF">2019-06-29T23:59:14Z</dcterms:modified>
</cp:coreProperties>
</file>